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6" r:id="rId2"/>
  </p:sldIdLst>
  <p:sldSz cx="12192000" cy="6858000"/>
  <p:notesSz cx="6858000" cy="9144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38" y="3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2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-Arbeitsblatt3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negativ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3!$B$9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3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Sheet3!$C$9:$H$9</c:f>
              <c:numCache>
                <c:formatCode>General</c:formatCode>
                <c:ptCount val="6"/>
                <c:pt idx="0">
                  <c:v>105695.28090000001</c:v>
                </c:pt>
                <c:pt idx="1">
                  <c:v>146510.29100000003</c:v>
                </c:pt>
                <c:pt idx="2">
                  <c:v>204841.66800000001</c:v>
                </c:pt>
                <c:pt idx="3">
                  <c:v>209952.15040000001</c:v>
                </c:pt>
                <c:pt idx="4">
                  <c:v>197339.35185454547</c:v>
                </c:pt>
                <c:pt idx="5">
                  <c:v>178548.1783333333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5D7-4C73-BA71-D377030172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0061152"/>
        <c:axId val="500071320"/>
      </c:lineChart>
      <c:scatterChart>
        <c:scatterStyle val="lineMarker"/>
        <c:varyColors val="0"/>
        <c:ser>
          <c:idx val="0"/>
          <c:order val="0"/>
          <c:tx>
            <c:strRef>
              <c:f>Sheet3!$B$4</c:f>
              <c:strCache>
                <c:ptCount val="1"/>
                <c:pt idx="0">
                  <c:v>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3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4:$H$4</c:f>
              <c:numCache>
                <c:formatCode>General</c:formatCode>
                <c:ptCount val="6"/>
                <c:pt idx="0">
                  <c:v>115892.7</c:v>
                </c:pt>
                <c:pt idx="1">
                  <c:v>133066.73000000001</c:v>
                </c:pt>
                <c:pt idx="2">
                  <c:v>180622.22</c:v>
                </c:pt>
                <c:pt idx="3">
                  <c:v>177569.35199999998</c:v>
                </c:pt>
                <c:pt idx="4">
                  <c:v>184373.33000000005</c:v>
                </c:pt>
                <c:pt idx="5">
                  <c:v>176762.2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75D7-4C73-BA71-D377030172B3}"/>
            </c:ext>
          </c:extLst>
        </c:ser>
        <c:ser>
          <c:idx val="1"/>
          <c:order val="1"/>
          <c:tx>
            <c:strRef>
              <c:f>Sheet3!$B$5</c:f>
              <c:strCache>
                <c:ptCount val="1"/>
                <c:pt idx="0">
                  <c:v>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3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5:$H$5</c:f>
              <c:numCache>
                <c:formatCode>General</c:formatCode>
                <c:ptCount val="6"/>
                <c:pt idx="0">
                  <c:v>150688.076</c:v>
                </c:pt>
                <c:pt idx="1">
                  <c:v>150693.04799999998</c:v>
                </c:pt>
                <c:pt idx="2">
                  <c:v>234689.4</c:v>
                </c:pt>
                <c:pt idx="3">
                  <c:v>186425.69400000002</c:v>
                </c:pt>
                <c:pt idx="4">
                  <c:v>182316.25</c:v>
                </c:pt>
                <c:pt idx="5">
                  <c:v>180263.8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75D7-4C73-BA71-D377030172B3}"/>
            </c:ext>
          </c:extLst>
        </c:ser>
        <c:ser>
          <c:idx val="2"/>
          <c:order val="2"/>
          <c:tx>
            <c:strRef>
              <c:f>Sheet3!$B$6</c:f>
              <c:strCache>
                <c:ptCount val="1"/>
                <c:pt idx="0">
                  <c:v>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3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6:$H$6</c:f>
              <c:numCache>
                <c:formatCode>General</c:formatCode>
                <c:ptCount val="6"/>
                <c:pt idx="0">
                  <c:v>16615.368000000002</c:v>
                </c:pt>
                <c:pt idx="1">
                  <c:v>114269.727</c:v>
                </c:pt>
                <c:pt idx="2">
                  <c:v>235343.68</c:v>
                </c:pt>
                <c:pt idx="3">
                  <c:v>171845.66199999998</c:v>
                </c:pt>
                <c:pt idx="4">
                  <c:v>171114.272</c:v>
                </c:pt>
                <c:pt idx="5">
                  <c:v>178618.4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75D7-4C73-BA71-D377030172B3}"/>
            </c:ext>
          </c:extLst>
        </c:ser>
        <c:ser>
          <c:idx val="3"/>
          <c:order val="3"/>
          <c:tx>
            <c:strRef>
              <c:f>Sheet3!$B$7</c:f>
              <c:strCache>
                <c:ptCount val="1"/>
                <c:pt idx="0">
                  <c:v>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3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7:$H$7</c:f>
              <c:numCache>
                <c:formatCode>General</c:formatCode>
                <c:ptCount val="6"/>
                <c:pt idx="0">
                  <c:v>83533.180500000002</c:v>
                </c:pt>
                <c:pt idx="1">
                  <c:v>156791.39000000001</c:v>
                </c:pt>
                <c:pt idx="2">
                  <c:v>206547.6</c:v>
                </c:pt>
                <c:pt idx="3">
                  <c:v>231523.47400000002</c:v>
                </c:pt>
                <c:pt idx="4">
                  <c:v>199620.1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75D7-4C73-BA71-D377030172B3}"/>
            </c:ext>
          </c:extLst>
        </c:ser>
        <c:ser>
          <c:idx val="4"/>
          <c:order val="4"/>
          <c:tx>
            <c:strRef>
              <c:f>Sheet3!$B$8</c:f>
              <c:strCache>
                <c:ptCount val="1"/>
                <c:pt idx="0">
                  <c:v>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3!$C$3:$H$3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8:$H$8</c:f>
              <c:numCache>
                <c:formatCode>General</c:formatCode>
                <c:ptCount val="6"/>
                <c:pt idx="0">
                  <c:v>161747.07999999999</c:v>
                </c:pt>
                <c:pt idx="1">
                  <c:v>177730.56</c:v>
                </c:pt>
                <c:pt idx="2">
                  <c:v>167005.44000000003</c:v>
                </c:pt>
                <c:pt idx="3">
                  <c:v>282396.57000000007</c:v>
                </c:pt>
                <c:pt idx="4">
                  <c:v>249272.7272727272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75D7-4C73-BA71-D377030172B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42302416"/>
        <c:axId val="442300776"/>
      </c:scatterChart>
      <c:catAx>
        <c:axId val="500061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0071320"/>
        <c:crosses val="autoZero"/>
        <c:auto val="1"/>
        <c:lblAlgn val="ctr"/>
        <c:lblOffset val="100"/>
        <c:noMultiLvlLbl val="0"/>
      </c:catAx>
      <c:valAx>
        <c:axId val="500071320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0" i="0" u="none" strike="noStrike" kern="1200" baseline="0">
                    <a:solidFill>
                      <a:sysClr val="windowText" lastClr="000000">
                        <a:lumMod val="65000"/>
                        <a:lumOff val="35000"/>
                      </a:sys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de-AT" sz="1000" b="0">
                    <a:effectLst/>
                  </a:rPr>
                  <a:t>10</a:t>
                </a:r>
                <a:r>
                  <a:rPr lang="de-AT" sz="1000" b="0" baseline="30000">
                    <a:effectLst/>
                  </a:rPr>
                  <a:t>5 </a:t>
                </a:r>
                <a:r>
                  <a:rPr lang="de-AT" sz="1000" b="0" baseline="0">
                    <a:effectLst/>
                  </a:rPr>
                  <a:t>cells</a:t>
                </a:r>
                <a:r>
                  <a:rPr lang="de-AT" sz="1000" b="0">
                    <a:effectLst/>
                  </a:rPr>
                  <a:t>/ml</a:t>
                </a:r>
              </a:p>
            </c:rich>
          </c:tx>
          <c:layout>
            <c:manualLayout>
              <c:xMode val="edge"/>
              <c:yMode val="edge"/>
              <c:x val="2.6060637151798082E-2"/>
              <c:y val="0.379051853771477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 marL="0" marR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000" b="0" i="0" u="none" strike="noStrike" kern="1200" baseline="0">
                  <a:solidFill>
                    <a:sysClr val="windowText" lastClr="000000">
                      <a:lumMod val="65000"/>
                      <a:lumOff val="35000"/>
                    </a:sysClr>
                  </a:solidFill>
                  <a:latin typeface="+mn-lt"/>
                  <a:ea typeface="+mn-ea"/>
                  <a:cs typeface="+mn-cs"/>
                </a:defRPr>
              </a:pPr>
              <a:endParaRPr lang="de-DE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0061152"/>
        <c:crosses val="autoZero"/>
        <c:crossBetween val="between"/>
        <c:majorUnit val="400000"/>
        <c:dispUnits>
          <c:builtInUnit val="hundredThousands"/>
        </c:dispUnits>
      </c:valAx>
      <c:valAx>
        <c:axId val="442300776"/>
        <c:scaling>
          <c:orientation val="minMax"/>
          <c:max val="1600000"/>
        </c:scaling>
        <c:delete val="1"/>
        <c:axPos val="r"/>
        <c:numFmt formatCode="General" sourceLinked="1"/>
        <c:majorTickMark val="out"/>
        <c:minorTickMark val="none"/>
        <c:tickLblPos val="nextTo"/>
        <c:crossAx val="442302416"/>
        <c:crosses val="max"/>
        <c:crossBetween val="midCat"/>
        <c:majorUnit val="400000"/>
      </c:valAx>
      <c:valAx>
        <c:axId val="442302416"/>
        <c:scaling>
          <c:orientation val="minMax"/>
        </c:scaling>
        <c:delete val="1"/>
        <c:axPos val="t"/>
        <c:majorTickMark val="out"/>
        <c:minorTickMark val="none"/>
        <c:tickLblPos val="nextTo"/>
        <c:crossAx val="44230077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ion-onl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3!$B$18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3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Sheet3!$C$18:$H$18</c:f>
              <c:numCache>
                <c:formatCode>General</c:formatCode>
                <c:ptCount val="6"/>
                <c:pt idx="0">
                  <c:v>406516.75559999997</c:v>
                </c:pt>
                <c:pt idx="1">
                  <c:v>264654.75800000003</c:v>
                </c:pt>
                <c:pt idx="2">
                  <c:v>372126.52500000002</c:v>
                </c:pt>
                <c:pt idx="3">
                  <c:v>258886.18799999999</c:v>
                </c:pt>
                <c:pt idx="4">
                  <c:v>129404.2788</c:v>
                </c:pt>
                <c:pt idx="5">
                  <c:v>227020.3356666666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D93-43AC-8E51-5FE81069E2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99673712"/>
        <c:axId val="499674040"/>
      </c:lineChart>
      <c:scatterChart>
        <c:scatterStyle val="lineMarker"/>
        <c:varyColors val="0"/>
        <c:ser>
          <c:idx val="0"/>
          <c:order val="0"/>
          <c:tx>
            <c:strRef>
              <c:f>Sheet3!$B$13</c:f>
              <c:strCache>
                <c:ptCount val="1"/>
                <c:pt idx="0">
                  <c:v>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3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13:$H$13</c:f>
              <c:numCache>
                <c:formatCode>General</c:formatCode>
                <c:ptCount val="6"/>
                <c:pt idx="0">
                  <c:v>146212.43</c:v>
                </c:pt>
                <c:pt idx="1">
                  <c:v>409550.4</c:v>
                </c:pt>
                <c:pt idx="2">
                  <c:v>145434.17499999999</c:v>
                </c:pt>
                <c:pt idx="3">
                  <c:v>287708.52</c:v>
                </c:pt>
                <c:pt idx="4">
                  <c:v>128181.6</c:v>
                </c:pt>
                <c:pt idx="5">
                  <c:v>302257.4400000000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D93-43AC-8E51-5FE81069E23A}"/>
            </c:ext>
          </c:extLst>
        </c:ser>
        <c:ser>
          <c:idx val="1"/>
          <c:order val="1"/>
          <c:tx>
            <c:strRef>
              <c:f>Sheet3!$B$14</c:f>
              <c:strCache>
                <c:ptCount val="1"/>
                <c:pt idx="0">
                  <c:v>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3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14:$H$14</c:f>
              <c:numCache>
                <c:formatCode>General</c:formatCode>
                <c:ptCount val="6"/>
                <c:pt idx="0">
                  <c:v>1518036.8</c:v>
                </c:pt>
                <c:pt idx="1">
                  <c:v>195375.375</c:v>
                </c:pt>
                <c:pt idx="2">
                  <c:v>294151.5</c:v>
                </c:pt>
                <c:pt idx="3">
                  <c:v>96144.18</c:v>
                </c:pt>
                <c:pt idx="4">
                  <c:v>86811.49</c:v>
                </c:pt>
                <c:pt idx="5">
                  <c:v>166758.40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D93-43AC-8E51-5FE81069E23A}"/>
            </c:ext>
          </c:extLst>
        </c:ser>
        <c:ser>
          <c:idx val="2"/>
          <c:order val="2"/>
          <c:tx>
            <c:strRef>
              <c:f>Sheet3!$B$15</c:f>
              <c:strCache>
                <c:ptCount val="1"/>
                <c:pt idx="0">
                  <c:v>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3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15:$H$15</c:f>
              <c:numCache>
                <c:formatCode>General</c:formatCode>
                <c:ptCount val="6"/>
                <c:pt idx="0">
                  <c:v>174569.82199999999</c:v>
                </c:pt>
                <c:pt idx="1">
                  <c:v>308998.21500000003</c:v>
                </c:pt>
                <c:pt idx="2">
                  <c:v>211688.1</c:v>
                </c:pt>
                <c:pt idx="3">
                  <c:v>366109.2</c:v>
                </c:pt>
                <c:pt idx="4">
                  <c:v>75344.983999999997</c:v>
                </c:pt>
                <c:pt idx="5">
                  <c:v>212045.1570000000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D93-43AC-8E51-5FE81069E23A}"/>
            </c:ext>
          </c:extLst>
        </c:ser>
        <c:ser>
          <c:idx val="3"/>
          <c:order val="3"/>
          <c:tx>
            <c:strRef>
              <c:f>Sheet3!$B$16</c:f>
              <c:strCache>
                <c:ptCount val="1"/>
                <c:pt idx="0">
                  <c:v>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3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16:$H$16</c:f>
              <c:numCache>
                <c:formatCode>General</c:formatCode>
                <c:ptCount val="6"/>
                <c:pt idx="0">
                  <c:v>45374.292000000001</c:v>
                </c:pt>
                <c:pt idx="1">
                  <c:v>171226.72</c:v>
                </c:pt>
                <c:pt idx="2">
                  <c:v>539804.93000000005</c:v>
                </c:pt>
                <c:pt idx="3">
                  <c:v>288532.86</c:v>
                </c:pt>
                <c:pt idx="4">
                  <c:v>269607.143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D93-43AC-8E51-5FE81069E23A}"/>
            </c:ext>
          </c:extLst>
        </c:ser>
        <c:ser>
          <c:idx val="4"/>
          <c:order val="4"/>
          <c:tx>
            <c:strRef>
              <c:f>Sheet3!$B$17</c:f>
              <c:strCache>
                <c:ptCount val="1"/>
                <c:pt idx="0">
                  <c:v>1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3!$C$12:$H$12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17:$H$17</c:f>
              <c:numCache>
                <c:formatCode>General</c:formatCode>
                <c:ptCount val="6"/>
                <c:pt idx="0">
                  <c:v>148390.43400000001</c:v>
                </c:pt>
                <c:pt idx="1">
                  <c:v>238123.08</c:v>
                </c:pt>
                <c:pt idx="2">
                  <c:v>669553.92000000004</c:v>
                </c:pt>
                <c:pt idx="3">
                  <c:v>255936.17999999996</c:v>
                </c:pt>
                <c:pt idx="4">
                  <c:v>87076.17600000002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D93-43AC-8E51-5FE81069E2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6342608"/>
        <c:axId val="416342280"/>
      </c:scatterChart>
      <c:catAx>
        <c:axId val="4996737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99674040"/>
        <c:crosses val="autoZero"/>
        <c:auto val="1"/>
        <c:lblAlgn val="ctr"/>
        <c:lblOffset val="100"/>
        <c:noMultiLvlLbl val="0"/>
      </c:catAx>
      <c:valAx>
        <c:axId val="499674040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99673712"/>
        <c:crosses val="autoZero"/>
        <c:crossBetween val="between"/>
        <c:majorUnit val="4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769744376278118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 i="0" baseline="0">
                      <a:effectLst/>
                    </a:rPr>
                    <a:t>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16342280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416342608"/>
        <c:crosses val="max"/>
        <c:crossBetween val="midCat"/>
      </c:valAx>
      <c:valAx>
        <c:axId val="416342608"/>
        <c:scaling>
          <c:orientation val="minMax"/>
        </c:scaling>
        <c:delete val="1"/>
        <c:axPos val="t"/>
        <c:majorTickMark val="out"/>
        <c:minorTickMark val="none"/>
        <c:tickLblPos val="nextTo"/>
        <c:crossAx val="416342280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challeng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3!$B$27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3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Sheet3!$C$27:$H$27</c:f>
              <c:numCache>
                <c:formatCode>General</c:formatCode>
                <c:ptCount val="6"/>
                <c:pt idx="0">
                  <c:v>58923.191899999998</c:v>
                </c:pt>
                <c:pt idx="1">
                  <c:v>284878.97699999996</c:v>
                </c:pt>
                <c:pt idx="2">
                  <c:v>34051.925999999999</c:v>
                </c:pt>
                <c:pt idx="3">
                  <c:v>383002.9</c:v>
                </c:pt>
                <c:pt idx="4">
                  <c:v>422542.30999999994</c:v>
                </c:pt>
                <c:pt idx="5">
                  <c:v>400198.7633333333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FB9-4F07-B628-F234D0FFDF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42236664"/>
        <c:axId val="442235024"/>
      </c:lineChart>
      <c:scatterChart>
        <c:scatterStyle val="lineMarker"/>
        <c:varyColors val="0"/>
        <c:ser>
          <c:idx val="0"/>
          <c:order val="0"/>
          <c:tx>
            <c:strRef>
              <c:f>Sheet3!$B$22</c:f>
              <c:strCache>
                <c:ptCount val="1"/>
                <c:pt idx="0">
                  <c:v>1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3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22:$H$22</c:f>
              <c:numCache>
                <c:formatCode>General</c:formatCode>
                <c:ptCount val="6"/>
                <c:pt idx="0">
                  <c:v>146634.88</c:v>
                </c:pt>
                <c:pt idx="1">
                  <c:v>278164.42499999999</c:v>
                </c:pt>
                <c:pt idx="2">
                  <c:v>15983.849999999999</c:v>
                </c:pt>
                <c:pt idx="3">
                  <c:v>282331.98</c:v>
                </c:pt>
                <c:pt idx="4">
                  <c:v>506691.36</c:v>
                </c:pt>
                <c:pt idx="5">
                  <c:v>408932.4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6FB9-4F07-B628-F234D0FFDF73}"/>
            </c:ext>
          </c:extLst>
        </c:ser>
        <c:ser>
          <c:idx val="1"/>
          <c:order val="1"/>
          <c:tx>
            <c:strRef>
              <c:f>Sheet3!$B$23</c:f>
              <c:strCache>
                <c:ptCount val="1"/>
                <c:pt idx="0">
                  <c:v>1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3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23:$H$23</c:f>
              <c:numCache>
                <c:formatCode>General</c:formatCode>
                <c:ptCount val="6"/>
                <c:pt idx="0">
                  <c:v>23905.183499999999</c:v>
                </c:pt>
                <c:pt idx="1">
                  <c:v>432729.59999999998</c:v>
                </c:pt>
                <c:pt idx="2">
                  <c:v>21695.040000000001</c:v>
                </c:pt>
                <c:pt idx="3">
                  <c:v>240007.1</c:v>
                </c:pt>
                <c:pt idx="4">
                  <c:v>408927.75</c:v>
                </c:pt>
                <c:pt idx="5">
                  <c:v>254878.6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6FB9-4F07-B628-F234D0FFDF73}"/>
            </c:ext>
          </c:extLst>
        </c:ser>
        <c:ser>
          <c:idx val="2"/>
          <c:order val="2"/>
          <c:tx>
            <c:strRef>
              <c:f>Sheet3!$B$24</c:f>
              <c:strCache>
                <c:ptCount val="1"/>
                <c:pt idx="0">
                  <c:v>1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3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24:$H$24</c:f>
              <c:numCache>
                <c:formatCode>General</c:formatCode>
                <c:ptCount val="6"/>
                <c:pt idx="0">
                  <c:v>26800.223999999998</c:v>
                </c:pt>
                <c:pt idx="1">
                  <c:v>325743.59999999998</c:v>
                </c:pt>
                <c:pt idx="2">
                  <c:v>29494.920000000006</c:v>
                </c:pt>
                <c:pt idx="3">
                  <c:v>331308.59999999998</c:v>
                </c:pt>
                <c:pt idx="4">
                  <c:v>312858</c:v>
                </c:pt>
                <c:pt idx="5">
                  <c:v>536785.199999999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6FB9-4F07-B628-F234D0FFDF73}"/>
            </c:ext>
          </c:extLst>
        </c:ser>
        <c:ser>
          <c:idx val="3"/>
          <c:order val="3"/>
          <c:tx>
            <c:strRef>
              <c:f>Sheet3!$B$25</c:f>
              <c:strCache>
                <c:ptCount val="1"/>
                <c:pt idx="0">
                  <c:v>1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3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25:$H$25</c:f>
              <c:numCache>
                <c:formatCode>General</c:formatCode>
                <c:ptCount val="6"/>
                <c:pt idx="0">
                  <c:v>42841.655999999995</c:v>
                </c:pt>
                <c:pt idx="1">
                  <c:v>230515.34000000003</c:v>
                </c:pt>
                <c:pt idx="2">
                  <c:v>13085.1</c:v>
                </c:pt>
                <c:pt idx="3">
                  <c:v>595261.05000000005</c:v>
                </c:pt>
                <c:pt idx="4">
                  <c:v>331468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6FB9-4F07-B628-F234D0FFDF73}"/>
            </c:ext>
          </c:extLst>
        </c:ser>
        <c:ser>
          <c:idx val="4"/>
          <c:order val="4"/>
          <c:tx>
            <c:strRef>
              <c:f>Sheet3!$B$26</c:f>
              <c:strCache>
                <c:ptCount val="1"/>
                <c:pt idx="0">
                  <c:v>1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3!$C$21:$H$21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Sheet3!$C$26:$H$26</c:f>
              <c:numCache>
                <c:formatCode>General</c:formatCode>
                <c:ptCount val="6"/>
                <c:pt idx="0">
                  <c:v>54434.016000000003</c:v>
                </c:pt>
                <c:pt idx="1">
                  <c:v>157241.92000000001</c:v>
                </c:pt>
                <c:pt idx="2">
                  <c:v>90000.72</c:v>
                </c:pt>
                <c:pt idx="3">
                  <c:v>466105.77</c:v>
                </c:pt>
                <c:pt idx="4">
                  <c:v>552766.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6FB9-4F07-B628-F234D0FFDF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9104096"/>
        <c:axId val="409103112"/>
      </c:scatterChart>
      <c:catAx>
        <c:axId val="4422366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2235024"/>
        <c:crosses val="autoZero"/>
        <c:auto val="1"/>
        <c:lblAlgn val="ctr"/>
        <c:lblOffset val="100"/>
        <c:noMultiLvlLbl val="0"/>
      </c:catAx>
      <c:valAx>
        <c:axId val="442235024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42236664"/>
        <c:crosses val="autoZero"/>
        <c:crossBetween val="between"/>
        <c:majorUnit val="400000"/>
        <c:dispUnits>
          <c:builtInUnit val="hundredThousands"/>
          <c:dispUnitsLbl>
            <c:layout>
              <c:manualLayout>
                <c:xMode val="edge"/>
                <c:yMode val="edge"/>
                <c:x val="1.895380941720767E-2"/>
                <c:y val="0.3423459441036128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 i="0" baseline="0">
                      <a:effectLst/>
                    </a:rPr>
                    <a:t>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09103112"/>
        <c:scaling>
          <c:orientation val="minMax"/>
          <c:max val="1600000"/>
        </c:scaling>
        <c:delete val="1"/>
        <c:axPos val="r"/>
        <c:numFmt formatCode="General" sourceLinked="1"/>
        <c:majorTickMark val="out"/>
        <c:minorTickMark val="none"/>
        <c:tickLblPos val="nextTo"/>
        <c:crossAx val="409104096"/>
        <c:crosses val="max"/>
        <c:crossBetween val="midCat"/>
      </c:valAx>
      <c:valAx>
        <c:axId val="409104096"/>
        <c:scaling>
          <c:orientation val="minMax"/>
        </c:scaling>
        <c:delete val="1"/>
        <c:axPos val="t"/>
        <c:majorTickMark val="out"/>
        <c:minorTickMark val="none"/>
        <c:tickLblPos val="nextTo"/>
        <c:crossAx val="409103112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ed/challenge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Sheet3!$B$36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Sheet3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cat>
          <c:val>
            <c:numRef>
              <c:f>Sheet3!$C$36:$G$36</c:f>
              <c:numCache>
                <c:formatCode>General</c:formatCode>
                <c:ptCount val="5"/>
                <c:pt idx="0">
                  <c:v>322211.60599999997</c:v>
                </c:pt>
                <c:pt idx="1">
                  <c:v>292041.42213333334</c:v>
                </c:pt>
                <c:pt idx="2">
                  <c:v>153085.69459999999</c:v>
                </c:pt>
                <c:pt idx="3">
                  <c:v>303553.9632</c:v>
                </c:pt>
                <c:pt idx="4">
                  <c:v>280127.57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431-4980-826D-126CA0ADDA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509804432"/>
        <c:axId val="509792952"/>
      </c:lineChart>
      <c:scatterChart>
        <c:scatterStyle val="lineMarker"/>
        <c:varyColors val="0"/>
        <c:ser>
          <c:idx val="0"/>
          <c:order val="0"/>
          <c:tx>
            <c:strRef>
              <c:f>Sheet3!$B$31</c:f>
              <c:strCache>
                <c:ptCount val="1"/>
                <c:pt idx="0">
                  <c:v>1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Sheet3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3!$C$31:$G$31</c:f>
              <c:numCache>
                <c:formatCode>General</c:formatCode>
                <c:ptCount val="5"/>
                <c:pt idx="0">
                  <c:v>202198.92</c:v>
                </c:pt>
                <c:pt idx="1">
                  <c:v>489102.66666666663</c:v>
                </c:pt>
                <c:pt idx="2">
                  <c:v>177948.68</c:v>
                </c:pt>
                <c:pt idx="3">
                  <c:v>60051.816000000006</c:v>
                </c:pt>
                <c:pt idx="4">
                  <c:v>264568.0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9431-4980-826D-126CA0ADDA2B}"/>
            </c:ext>
          </c:extLst>
        </c:ser>
        <c:ser>
          <c:idx val="1"/>
          <c:order val="1"/>
          <c:tx>
            <c:strRef>
              <c:f>Sheet3!$B$32</c:f>
              <c:strCache>
                <c:ptCount val="1"/>
                <c:pt idx="0">
                  <c:v>1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Sheet3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3!$C$32:$G$32</c:f>
              <c:numCache>
                <c:formatCode>General</c:formatCode>
                <c:ptCount val="5"/>
                <c:pt idx="0">
                  <c:v>230063.96</c:v>
                </c:pt>
                <c:pt idx="1">
                  <c:v>332365.68</c:v>
                </c:pt>
                <c:pt idx="2">
                  <c:v>96547.07699999999</c:v>
                </c:pt>
                <c:pt idx="3">
                  <c:v>285584.25</c:v>
                </c:pt>
                <c:pt idx="4">
                  <c:v>295687.0799999999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9431-4980-826D-126CA0ADDA2B}"/>
            </c:ext>
          </c:extLst>
        </c:ser>
        <c:ser>
          <c:idx val="2"/>
          <c:order val="2"/>
          <c:tx>
            <c:strRef>
              <c:f>Sheet3!$B$33</c:f>
              <c:strCache>
                <c:ptCount val="1"/>
                <c:pt idx="0">
                  <c:v>1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Sheet3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3!$C$33:$G$33</c:f>
              <c:numCache>
                <c:formatCode>General</c:formatCode>
                <c:ptCount val="5"/>
                <c:pt idx="0">
                  <c:v>447926.64</c:v>
                </c:pt>
                <c:pt idx="1">
                  <c:v>219047.4</c:v>
                </c:pt>
                <c:pt idx="2">
                  <c:v>57751.343999999997</c:v>
                </c:pt>
                <c:pt idx="3">
                  <c:v>127944.7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9431-4980-826D-126CA0ADDA2B}"/>
            </c:ext>
          </c:extLst>
        </c:ser>
        <c:ser>
          <c:idx val="3"/>
          <c:order val="3"/>
          <c:tx>
            <c:strRef>
              <c:f>Sheet3!$B$34</c:f>
              <c:strCache>
                <c:ptCount val="1"/>
                <c:pt idx="0">
                  <c:v>1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Sheet3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3!$C$34:$G$34</c:f>
              <c:numCache>
                <c:formatCode>General</c:formatCode>
                <c:ptCount val="5"/>
                <c:pt idx="0">
                  <c:v>475770.15</c:v>
                </c:pt>
                <c:pt idx="1">
                  <c:v>409990.42</c:v>
                </c:pt>
                <c:pt idx="2">
                  <c:v>199176.872</c:v>
                </c:pt>
                <c:pt idx="3">
                  <c:v>847717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9431-4980-826D-126CA0ADDA2B}"/>
            </c:ext>
          </c:extLst>
        </c:ser>
        <c:ser>
          <c:idx val="4"/>
          <c:order val="4"/>
          <c:tx>
            <c:strRef>
              <c:f>Sheet3!$B$35</c:f>
              <c:strCache>
                <c:ptCount val="1"/>
                <c:pt idx="0">
                  <c:v>2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Sheet3!$C$30:$G$30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Sheet3!$C$35:$G$35</c:f>
              <c:numCache>
                <c:formatCode>General</c:formatCode>
                <c:ptCount val="5"/>
                <c:pt idx="0">
                  <c:v>255098.36</c:v>
                </c:pt>
                <c:pt idx="1">
                  <c:v>9700.9439999999995</c:v>
                </c:pt>
                <c:pt idx="2">
                  <c:v>234004.5</c:v>
                </c:pt>
                <c:pt idx="3">
                  <c:v>196471.4699999999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9431-4980-826D-126CA0ADDA2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500048688"/>
        <c:axId val="500062136"/>
      </c:scatterChart>
      <c:catAx>
        <c:axId val="5098044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9792952"/>
        <c:crosses val="autoZero"/>
        <c:auto val="1"/>
        <c:lblAlgn val="ctr"/>
        <c:lblOffset val="100"/>
        <c:noMultiLvlLbl val="0"/>
      </c:catAx>
      <c:valAx>
        <c:axId val="509792952"/>
        <c:scaling>
          <c:orientation val="minMax"/>
          <c:max val="16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509804432"/>
        <c:crosses val="autoZero"/>
        <c:crossBetween val="between"/>
        <c:majorUnit val="4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423459441036128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 i="0" baseline="0">
                      <a:effectLst/>
                    </a:rPr>
                    <a:t>10</a:t>
                  </a:r>
                  <a:r>
                    <a:rPr lang="de-AT" sz="1000" b="0" i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 i="0" baseline="0">
                      <a:effectLst/>
                    </a:rPr>
                    <a:t>/ml</a:t>
                  </a:r>
                  <a:endParaRPr lang="de-AT" sz="1000">
                    <a:effectLst/>
                  </a:endParaRP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500062136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500048688"/>
        <c:crosses val="max"/>
        <c:crossBetween val="midCat"/>
      </c:valAx>
      <c:valAx>
        <c:axId val="500048688"/>
        <c:scaling>
          <c:orientation val="minMax"/>
        </c:scaling>
        <c:delete val="1"/>
        <c:axPos val="t"/>
        <c:majorTickMark val="out"/>
        <c:minorTickMark val="none"/>
        <c:tickLblPos val="nextTo"/>
        <c:crossAx val="50006213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62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253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40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678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19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70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198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089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54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3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7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337393" y="181408"/>
            <a:ext cx="11475489" cy="6370039"/>
            <a:chOff x="337393" y="181408"/>
            <a:chExt cx="11475489" cy="6370039"/>
          </a:xfrm>
        </p:grpSpPr>
        <p:grpSp>
          <p:nvGrpSpPr>
            <p:cNvPr id="12" name="Group 11"/>
            <p:cNvGrpSpPr/>
            <p:nvPr/>
          </p:nvGrpSpPr>
          <p:grpSpPr>
            <a:xfrm>
              <a:off x="337393" y="181408"/>
              <a:ext cx="11475489" cy="6370039"/>
              <a:chOff x="337393" y="181408"/>
              <a:chExt cx="11475489" cy="6370039"/>
            </a:xfrm>
          </p:grpSpPr>
          <p:graphicFrame>
            <p:nvGraphicFramePr>
              <p:cNvPr id="4" name="Chart 3"/>
              <p:cNvGraphicFramePr/>
              <p:nvPr>
                <p:extLst>
                  <p:ext uri="{D42A27DB-BD31-4B8C-83A1-F6EECF244321}">
                    <p14:modId xmlns:p14="http://schemas.microsoft.com/office/powerpoint/2010/main" val="2080151130"/>
                  </p:ext>
                </p:extLst>
              </p:nvPr>
            </p:nvGraphicFramePr>
            <p:xfrm>
              <a:off x="496526" y="280086"/>
              <a:ext cx="5360575" cy="293267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5" name="Chart 4"/>
              <p:cNvGraphicFramePr/>
              <p:nvPr>
                <p:extLst>
                  <p:ext uri="{D42A27DB-BD31-4B8C-83A1-F6EECF244321}">
                    <p14:modId xmlns:p14="http://schemas.microsoft.com/office/powerpoint/2010/main" val="3133524679"/>
                  </p:ext>
                </p:extLst>
              </p:nvPr>
            </p:nvGraphicFramePr>
            <p:xfrm>
              <a:off x="6452482" y="280086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6" name="Chart 5"/>
              <p:cNvGraphicFramePr/>
              <p:nvPr>
                <p:extLst>
                  <p:ext uri="{D42A27DB-BD31-4B8C-83A1-F6EECF244321}">
                    <p14:modId xmlns:p14="http://schemas.microsoft.com/office/powerpoint/2010/main" val="2628839681"/>
                  </p:ext>
                </p:extLst>
              </p:nvPr>
            </p:nvGraphicFramePr>
            <p:xfrm>
              <a:off x="496526" y="3617447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7" name="Chart 6"/>
              <p:cNvGraphicFramePr/>
              <p:nvPr>
                <p:extLst>
                  <p:ext uri="{D42A27DB-BD31-4B8C-83A1-F6EECF244321}">
                    <p14:modId xmlns:p14="http://schemas.microsoft.com/office/powerpoint/2010/main" val="2877298709"/>
                  </p:ext>
                </p:extLst>
              </p:nvPr>
            </p:nvGraphicFramePr>
            <p:xfrm>
              <a:off x="6452482" y="3617447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337393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A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185622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B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7393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C</a:t>
                </a:r>
                <a:endParaRPr lang="en-GB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185622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D</a:t>
                </a:r>
                <a:endParaRPr lang="en-GB" dirty="0"/>
              </a:p>
            </p:txBody>
          </p:sp>
        </p:grpSp>
        <p:sp>
          <p:nvSpPr>
            <p:cNvPr id="13" name="TextBox 12"/>
            <p:cNvSpPr txBox="1"/>
            <p:nvPr/>
          </p:nvSpPr>
          <p:spPr>
            <a:xfrm>
              <a:off x="8089436" y="1824118"/>
              <a:ext cx="180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6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2139877" y="5193393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910115" y="5601166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4454709" y="5058208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7401661" y="5155868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8119937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</Words>
  <Application>Microsoft Office PowerPoint</Application>
  <PresentationFormat>Widescreen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Luca Carlotta</dc:creator>
  <cp:lastModifiedBy>De Luca Carlotta</cp:lastModifiedBy>
  <cp:revision>12</cp:revision>
  <dcterms:created xsi:type="dcterms:W3CDTF">2020-07-30T11:05:44Z</dcterms:created>
  <dcterms:modified xsi:type="dcterms:W3CDTF">2020-07-30T12:19:34Z</dcterms:modified>
</cp:coreProperties>
</file>